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7B6E02-EEB4-420F-B627-6D856C0FDE0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AB1D5D-75C4-4511-8035-E552261BD33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1EF243-D23F-4C17-B86C-C860E77CFA4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0771A2-4720-4D50-A3EF-E9AA85AADC0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E2BE32-8D7D-4DE9-AA4B-046C7B212ED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5579BD-3818-46AE-889A-064752CF3C6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FEDAC7-5B95-41D6-AE45-679134115A0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641509-D593-425B-A3EA-414E0310F66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4F36B1-D62B-47DB-AF7D-7FED2462BCD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093A8F-22EE-44D7-8CD1-C98F47DCB0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8A841B-7C90-4EEC-A9E9-D2D175405E8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32D742-03E7-4FA3-ABE9-6CFA6B9BA5F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49237ED-F28E-43CF-AF8B-669F0E36C3A8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8"/>
          <p:cNvSpPr/>
          <p:nvPr/>
        </p:nvSpPr>
        <p:spPr>
          <a:xfrm>
            <a:off x="990720" y="606600"/>
            <a:ext cx="1295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6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26"/>
          <p:cNvGrpSpPr/>
          <p:nvPr/>
        </p:nvGrpSpPr>
        <p:grpSpPr>
          <a:xfrm>
            <a:off x="1041480" y="1033560"/>
            <a:ext cx="5093640" cy="7076880"/>
            <a:chOff x="1041480" y="1033560"/>
            <a:chExt cx="5093640" cy="7076880"/>
          </a:xfrm>
        </p:grpSpPr>
        <p:pic>
          <p:nvPicPr>
            <p:cNvPr id="43" name="Picture 2" descr=""/>
            <p:cNvPicPr/>
            <p:nvPr/>
          </p:nvPicPr>
          <p:blipFill>
            <a:blip r:embed="rId1"/>
            <a:srcRect l="0" t="0" r="18198" b="0"/>
            <a:stretch/>
          </p:blipFill>
          <p:spPr>
            <a:xfrm>
              <a:off x="1041480" y="1033560"/>
              <a:ext cx="3530880" cy="7076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Right Brace 8"/>
            <p:cNvSpPr/>
            <p:nvPr/>
          </p:nvSpPr>
          <p:spPr>
            <a:xfrm>
              <a:off x="5718600" y="5434200"/>
              <a:ext cx="152280" cy="2057400"/>
            </a:xfrm>
            <a:custGeom>
              <a:avLst/>
              <a:gdLst>
                <a:gd name="textAreaLeft" fmla="*/ 0 w 152280"/>
                <a:gd name="textAreaRight" fmla="*/ 55080 w 152280"/>
                <a:gd name="textAreaTop" fmla="*/ 3960 h 2057400"/>
                <a:gd name="textAreaBottom" fmla="*/ 2053440 h 20574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67"/>
                    <a:pt x="10800" y="133"/>
                  </a:cubicBezTo>
                  <a:lnTo>
                    <a:pt x="10800" y="10667"/>
                  </a:lnTo>
                  <a:cubicBezTo>
                    <a:pt x="10800" y="10734"/>
                    <a:pt x="16200" y="10800"/>
                    <a:pt x="21600" y="10800"/>
                  </a:cubicBezTo>
                  <a:cubicBezTo>
                    <a:pt x="16200" y="10800"/>
                    <a:pt x="10800" y="10867"/>
                    <a:pt x="10800" y="10933"/>
                  </a:cubicBezTo>
                  <a:lnTo>
                    <a:pt x="10800" y="21467"/>
                  </a:lnTo>
                  <a:cubicBezTo>
                    <a:pt x="10800" y="21534"/>
                    <a:pt x="5400" y="21600"/>
                    <a:pt x="0" y="21600"/>
                  </a:cubicBezTo>
                </a:path>
              </a:pathLst>
            </a:custGeom>
            <a:noFill/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Right Brace 9"/>
            <p:cNvSpPr/>
            <p:nvPr/>
          </p:nvSpPr>
          <p:spPr>
            <a:xfrm>
              <a:off x="5735880" y="1280880"/>
              <a:ext cx="152280" cy="2438280"/>
            </a:xfrm>
            <a:custGeom>
              <a:avLst/>
              <a:gdLst>
                <a:gd name="textAreaLeft" fmla="*/ 0 w 152280"/>
                <a:gd name="textAreaRight" fmla="*/ 55080 w 152280"/>
                <a:gd name="textAreaTop" fmla="*/ 3600 h 2438280"/>
                <a:gd name="textAreaBottom" fmla="*/ 2434680 h 2438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56"/>
                    <a:pt x="10800" y="112"/>
                  </a:cubicBezTo>
                  <a:lnTo>
                    <a:pt x="10800" y="10688"/>
                  </a:lnTo>
                  <a:cubicBezTo>
                    <a:pt x="10800" y="10744"/>
                    <a:pt x="16200" y="10800"/>
                    <a:pt x="21600" y="10800"/>
                  </a:cubicBezTo>
                  <a:cubicBezTo>
                    <a:pt x="16200" y="10800"/>
                    <a:pt x="10800" y="10856"/>
                    <a:pt x="10800" y="10912"/>
                  </a:cubicBezTo>
                  <a:lnTo>
                    <a:pt x="10800" y="21488"/>
                  </a:lnTo>
                  <a:cubicBezTo>
                    <a:pt x="10800" y="21544"/>
                    <a:pt x="5400" y="21600"/>
                    <a:pt x="0" y="21600"/>
                  </a:cubicBezTo>
                </a:path>
              </a:pathLst>
            </a:custGeom>
            <a:noFill/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Box 11"/>
            <p:cNvSpPr/>
            <p:nvPr/>
          </p:nvSpPr>
          <p:spPr>
            <a:xfrm rot="16200000">
              <a:off x="5448240" y="2314440"/>
              <a:ext cx="10666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ubgroup I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Box 12"/>
            <p:cNvSpPr/>
            <p:nvPr/>
          </p:nvSpPr>
          <p:spPr>
            <a:xfrm rot="16200000">
              <a:off x="5360760" y="4276800"/>
              <a:ext cx="12412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ubgroup II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Box 13"/>
            <p:cNvSpPr/>
            <p:nvPr/>
          </p:nvSpPr>
          <p:spPr>
            <a:xfrm rot="16200000">
              <a:off x="5271120" y="6179400"/>
              <a:ext cx="14205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ubgroup III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Box 4"/>
            <p:cNvSpPr/>
            <p:nvPr/>
          </p:nvSpPr>
          <p:spPr>
            <a:xfrm>
              <a:off x="4523040" y="1143000"/>
              <a:ext cx="12189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mG</a:t>
              </a:r>
              <a:r>
                <a:rPr b="1" lang="en-US" sz="1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</a:t>
              </a: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Box 5"/>
            <p:cNvSpPr/>
            <p:nvPr/>
          </p:nvSpPr>
          <p:spPr>
            <a:xfrm>
              <a:off x="4508640" y="1508040"/>
              <a:ext cx="12189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mG</a:t>
              </a:r>
              <a:r>
                <a:rPr b="1" lang="en-US" sz="1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</a:t>
              </a: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Box 6"/>
            <p:cNvSpPr/>
            <p:nvPr/>
          </p:nvSpPr>
          <p:spPr>
            <a:xfrm>
              <a:off x="4499280" y="3041640"/>
              <a:ext cx="12189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mG</a:t>
              </a:r>
              <a:r>
                <a:rPr b="1" lang="en-US" sz="1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</a:t>
              </a: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Box 7"/>
            <p:cNvSpPr/>
            <p:nvPr/>
          </p:nvSpPr>
          <p:spPr>
            <a:xfrm>
              <a:off x="4507200" y="3429000"/>
              <a:ext cx="12189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mG</a:t>
              </a:r>
              <a:r>
                <a:rPr b="1" lang="en-US" sz="1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</a:t>
              </a: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Box 8"/>
            <p:cNvSpPr/>
            <p:nvPr/>
          </p:nvSpPr>
          <p:spPr>
            <a:xfrm>
              <a:off x="4508640" y="4548240"/>
              <a:ext cx="12189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mG</a:t>
              </a:r>
              <a:r>
                <a:rPr b="1" lang="en-US" sz="1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</a:t>
              </a: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5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Box 9"/>
            <p:cNvSpPr/>
            <p:nvPr/>
          </p:nvSpPr>
          <p:spPr>
            <a:xfrm>
              <a:off x="4508640" y="4940280"/>
              <a:ext cx="12189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mG</a:t>
              </a:r>
              <a:r>
                <a:rPr b="1" lang="en-US" sz="1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</a:t>
              </a: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6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Box 10"/>
            <p:cNvSpPr/>
            <p:nvPr/>
          </p:nvSpPr>
          <p:spPr>
            <a:xfrm>
              <a:off x="4499280" y="4178160"/>
              <a:ext cx="12189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mG</a:t>
              </a:r>
              <a:r>
                <a:rPr b="1" lang="en-US" sz="1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</a:t>
              </a: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7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Box 11"/>
            <p:cNvSpPr/>
            <p:nvPr/>
          </p:nvSpPr>
          <p:spPr>
            <a:xfrm>
              <a:off x="4507200" y="6845400"/>
              <a:ext cx="12189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mG</a:t>
              </a:r>
              <a:r>
                <a:rPr b="1" lang="en-US" sz="1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</a:t>
              </a: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8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Box 12"/>
            <p:cNvSpPr/>
            <p:nvPr/>
          </p:nvSpPr>
          <p:spPr>
            <a:xfrm>
              <a:off x="4507200" y="7205760"/>
              <a:ext cx="12189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mG</a:t>
              </a:r>
              <a:r>
                <a:rPr b="1" lang="en-US" sz="1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</a:t>
              </a: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9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Box 13"/>
            <p:cNvSpPr/>
            <p:nvPr/>
          </p:nvSpPr>
          <p:spPr>
            <a:xfrm>
              <a:off x="4507200" y="5318280"/>
              <a:ext cx="12189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mG</a:t>
              </a:r>
              <a:r>
                <a:rPr b="1" lang="en-US" sz="1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</a:t>
              </a: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Box 5"/>
            <p:cNvSpPr/>
            <p:nvPr/>
          </p:nvSpPr>
          <p:spPr>
            <a:xfrm>
              <a:off x="4508640" y="1892160"/>
              <a:ext cx="12189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GG1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Box 5"/>
            <p:cNvSpPr/>
            <p:nvPr/>
          </p:nvSpPr>
          <p:spPr>
            <a:xfrm>
              <a:off x="4508640" y="2260440"/>
              <a:ext cx="12189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GG1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Box 5"/>
            <p:cNvSpPr/>
            <p:nvPr/>
          </p:nvSpPr>
          <p:spPr>
            <a:xfrm>
              <a:off x="4508640" y="2633760"/>
              <a:ext cx="12189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GG2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Box 5"/>
            <p:cNvSpPr/>
            <p:nvPr/>
          </p:nvSpPr>
          <p:spPr>
            <a:xfrm>
              <a:off x="4508640" y="3784680"/>
              <a:ext cx="12189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GG2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Box 5"/>
            <p:cNvSpPr/>
            <p:nvPr/>
          </p:nvSpPr>
          <p:spPr>
            <a:xfrm>
              <a:off x="4508640" y="5702400"/>
              <a:ext cx="12189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S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Box 5"/>
            <p:cNvSpPr/>
            <p:nvPr/>
          </p:nvSpPr>
          <p:spPr>
            <a:xfrm>
              <a:off x="4508640" y="6075360"/>
              <a:ext cx="12189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EP1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TextBox 5"/>
            <p:cNvSpPr/>
            <p:nvPr/>
          </p:nvSpPr>
          <p:spPr>
            <a:xfrm>
              <a:off x="4496040" y="6451560"/>
              <a:ext cx="1295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5g20635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Right Brace 30"/>
            <p:cNvSpPr/>
            <p:nvPr/>
          </p:nvSpPr>
          <p:spPr>
            <a:xfrm>
              <a:off x="5727960" y="3862440"/>
              <a:ext cx="152280" cy="1371600"/>
            </a:xfrm>
            <a:custGeom>
              <a:avLst/>
              <a:gdLst>
                <a:gd name="textAreaLeft" fmla="*/ 0 w 152280"/>
                <a:gd name="textAreaRight" fmla="*/ 55080 w 152280"/>
                <a:gd name="textAreaTop" fmla="*/ 3960 h 1371600"/>
                <a:gd name="textAreaBottom" fmla="*/ 1367640 h 13716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100"/>
                    <a:pt x="10800" y="200"/>
                  </a:cubicBezTo>
                  <a:lnTo>
                    <a:pt x="10800" y="10600"/>
                  </a:lnTo>
                  <a:cubicBezTo>
                    <a:pt x="10800" y="10700"/>
                    <a:pt x="16200" y="10800"/>
                    <a:pt x="21600" y="10800"/>
                  </a:cubicBezTo>
                  <a:cubicBezTo>
                    <a:pt x="16200" y="10800"/>
                    <a:pt x="10800" y="10900"/>
                    <a:pt x="10800" y="11000"/>
                  </a:cubicBezTo>
                  <a:lnTo>
                    <a:pt x="10800" y="21400"/>
                  </a:lnTo>
                  <a:cubicBezTo>
                    <a:pt x="10800" y="21500"/>
                    <a:pt x="5400" y="21600"/>
                    <a:pt x="0" y="21600"/>
                  </a:cubicBezTo>
                </a:path>
              </a:pathLst>
            </a:custGeom>
            <a:noFill/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16T22:32:03Z</dcterms:created>
  <dc:creator>Tate, Jeremy</dc:creator>
  <dc:description/>
  <dc:language>en-US</dc:language>
  <cp:lastModifiedBy>Tate, Jeremy</cp:lastModifiedBy>
  <dcterms:modified xsi:type="dcterms:W3CDTF">2011-04-20T23:07:30Z</dcterms:modified>
  <cp:revision>16</cp:revision>
  <dc:subject/>
  <dc:title>Slide 1</dc:title>
</cp:coreProperties>
</file>